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notesMasterIdLst>
    <p:notesMasterId r:id="rId7"/>
  </p:notesMasterIdLst>
  <p:sldIdLst>
    <p:sldId id="266" r:id="rId5"/>
    <p:sldId id="267" r:id="rId6"/>
  </p:sldIdLst>
  <p:sldSz cx="9906000" cy="6858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4668914-734A-F588-4C2E-AD37DA8B2E13}" name="Anthony Swain" initials="AS" userId="Anthony Swain" providerId="None"/>
  <p188:author id="{70902516-887B-7F19-741A-F09906C0671F}" name="HR" initials="HR" userId="HR" providerId="None"/>
  <p188:author id="{73DC2D18-E922-1A87-274C-F0F2E807C9E6}" name="Kazutaka Nozawa" initials="KN" userId="S::Kazutaka.Nozawa@viatris.com::841af96d-8e35-44f5-9dc0-019aadf1d869" providerId="AD"/>
  <p188:author id="{07F33623-F42E-4497-1180-01854E2EBC7E}" name="Internal Reviewer" initials="IR" userId="Internal Reviewer" providerId="None"/>
  <p188:author id="{E68DBF29-173B-1EE4-E980-EBF86C79181A}" name="Editor" initials="Ed" userId="Editor" providerId="None"/>
  <p188:author id="{E723EF5A-5AE6-60CB-892A-AEC87E9AC41A}" name="作成者" initials="作成者" userId="作成者" providerId="None"/>
  <p188:author id="{8F4F1484-770B-D90B-A95A-C4CCDCB84F04}" name="Writer" initials="W" userId="Writer" providerId="None"/>
  <p188:author id="{DD2170A0-2867-4769-1D9A-485A22681402}" name="柴田 光貴(Mebix)" initials="柴光" userId="S::koki.shibata@group-m3.com::4d796755-eff1-4b8b-bf14-cc98ce33cf8a" providerId="AD"/>
  <p188:author id="{251943E6-8A93-1EE3-C4EF-1CC383743658}" name="Yusuke Karasawa" initials="YK" userId="S::Yusuke.Karasawa@viatris.com::96ef4b0b-736d-4e83-854b-ac9ecc659279" providerId="AD"/>
  <p188:author id="{36CD49ED-C61A-507A-B022-D25116DC5098}" name="MK" initials="作成者" userId="MK" providerId="None"/>
  <p188:author id="{E86AD2FB-790D-8CFC-C1DB-7D5FA0F81025}" name="JMW" initials="JMW" userId="JMW" providerId="Non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A.Mizukami (Mebix)" initials="水上" lastIdx="2" clrIdx="6">
    <p:extLst>
      <p:ext uri="{19B8F6BF-5375-455C-9EA6-DF929625EA0E}">
        <p15:presenceInfo xmlns:p15="http://schemas.microsoft.com/office/powerpoint/2012/main" userId="A.Mizukami (Mebix)" providerId="None"/>
      </p:ext>
    </p:extLst>
  </p:cmAuthor>
  <p:cmAuthor id="1" name="柴田 光貴(Mebix)" initials="柴田" lastIdx="4" clrIdx="0">
    <p:extLst>
      <p:ext uri="{19B8F6BF-5375-455C-9EA6-DF929625EA0E}">
        <p15:presenceInfo xmlns:p15="http://schemas.microsoft.com/office/powerpoint/2012/main" userId="S-1-5-21-56794912-1431433800-2504997980-13609" providerId="AD"/>
      </p:ext>
    </p:extLst>
  </p:cmAuthor>
  <p:cmAuthor id="2" name="Michelle Belanger" initials="MB" lastIdx="2" clrIdx="1">
    <p:extLst>
      <p:ext uri="{19B8F6BF-5375-455C-9EA6-DF929625EA0E}">
        <p15:presenceInfo xmlns:p15="http://schemas.microsoft.com/office/powerpoint/2012/main" userId="Michelle Belanger" providerId="None"/>
      </p:ext>
    </p:extLst>
  </p:cmAuthor>
  <p:cmAuthor id="3" name="Internal Reviewer" initials="IR" lastIdx="5" clrIdx="2">
    <p:extLst>
      <p:ext uri="{19B8F6BF-5375-455C-9EA6-DF929625EA0E}">
        <p15:presenceInfo xmlns:p15="http://schemas.microsoft.com/office/powerpoint/2012/main" userId="Internal Reviewer" providerId="None"/>
      </p:ext>
    </p:extLst>
  </p:cmAuthor>
  <p:cmAuthor id="4" name="Yusuke Karasawa" initials="YK" lastIdx="3" clrIdx="3">
    <p:extLst>
      <p:ext uri="{19B8F6BF-5375-455C-9EA6-DF929625EA0E}">
        <p15:presenceInfo xmlns:p15="http://schemas.microsoft.com/office/powerpoint/2012/main" userId="S::Yusuke.Karasawa@viatris.com::96ef4b0b-736d-4e83-854b-ac9ecc659279" providerId="AD"/>
      </p:ext>
    </p:extLst>
  </p:cmAuthor>
  <p:cmAuthor id="5" name="Keyra Martinez Dunn" initials="KMD" lastIdx="2" clrIdx="4">
    <p:extLst>
      <p:ext uri="{19B8F6BF-5375-455C-9EA6-DF929625EA0E}">
        <p15:presenceInfo xmlns:p15="http://schemas.microsoft.com/office/powerpoint/2012/main" userId="Keyra Martinez Dunn" providerId="None"/>
      </p:ext>
    </p:extLst>
  </p:cmAuthor>
  <p:cmAuthor id="6" name="QC-JN" initials="QC-JN" lastIdx="1" clrIdx="5">
    <p:extLst>
      <p:ext uri="{19B8F6BF-5375-455C-9EA6-DF929625EA0E}">
        <p15:presenceInfo xmlns:p15="http://schemas.microsoft.com/office/powerpoint/2012/main" userId="QC-J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F5F5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8434" autoAdjust="0"/>
  </p:normalViewPr>
  <p:slideViewPr>
    <p:cSldViewPr snapToGrid="0">
      <p:cViewPr varScale="1">
        <p:scale>
          <a:sx n="84" d="100"/>
          <a:sy n="84" d="100"/>
        </p:scale>
        <p:origin x="1588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usuke Karasawa" userId="96ef4b0b-736d-4e83-854b-ac9ecc659279" providerId="ADAL" clId="{55DE238F-D4A3-4928-8C41-5823065FA803}"/>
    <pc:docChg chg="modSld">
      <pc:chgData name="Yusuke Karasawa" userId="96ef4b0b-736d-4e83-854b-ac9ecc659279" providerId="ADAL" clId="{55DE238F-D4A3-4928-8C41-5823065FA803}" dt="2023-09-20T07:28:49.754" v="2" actId="20577"/>
      <pc:docMkLst>
        <pc:docMk/>
      </pc:docMkLst>
      <pc:sldChg chg="modSp mod">
        <pc:chgData name="Yusuke Karasawa" userId="96ef4b0b-736d-4e83-854b-ac9ecc659279" providerId="ADAL" clId="{55DE238F-D4A3-4928-8C41-5823065FA803}" dt="2023-09-20T07:28:49.754" v="2" actId="20577"/>
        <pc:sldMkLst>
          <pc:docMk/>
          <pc:sldMk cId="3800145843" sldId="267"/>
        </pc:sldMkLst>
        <pc:spChg chg="mod">
          <ac:chgData name="Yusuke Karasawa" userId="96ef4b0b-736d-4e83-854b-ac9ecc659279" providerId="ADAL" clId="{55DE238F-D4A3-4928-8C41-5823065FA803}" dt="2023-09-20T07:28:49.754" v="2" actId="20577"/>
          <ac:spMkLst>
            <pc:docMk/>
            <pc:sldMk cId="3800145843" sldId="267"/>
            <ac:spMk id="2" creationId="{6C28E5F3-550D-F7A5-17C8-ABB6BAC43D7C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hronic pain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>
              <a:outerShdw blurRad="63500" sx="102000" sy="102000" algn="ctr" rotWithShape="0">
                <a:prstClr val="black">
                  <a:alpha val="20000"/>
                </a:prstClr>
              </a:outerShdw>
            </a:effectLst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47D5-4FB4-BF6E-6AD4D8DDE98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47D5-4FB4-BF6E-6AD4D8DDE98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47D5-4FB4-BF6E-6AD4D8DDE984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47D5-4FB4-BF6E-6AD4D8DDE984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7D5-4FB4-BF6E-6AD4D8DDE984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7D5-4FB4-BF6E-6AD4D8DDE984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47D5-4FB4-BF6E-6AD4D8DDE984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47D5-4FB4-BF6E-6AD4D8DDE984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47D5-4FB4-BF6E-6AD4D8DDE984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47D5-4FB4-BF6E-6AD4D8DDE98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694FC891-CC06-4370-98A5-D8BC1898B166}" type="VALUE">
                      <a:rPr lang="en-US" altLang="ja-JP" smtClean="0"/>
                      <a:pPr/>
                      <a:t>[値]</a:t>
                    </a:fld>
                    <a:r>
                      <a:rPr lang="en-US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47D5-4FB4-BF6E-6AD4D8DDE984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1330" b="1" i="0" u="none" strike="noStrike" kern="1200" spc="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34C8B33D-5414-4248-9144-AA157632EAAB}" type="VALUE">
                      <a:rPr lang="en-US" altLang="ja-JP" smtClean="0">
                        <a:solidFill>
                          <a:schemeClr val="tx1"/>
                        </a:solidFill>
                      </a:rPr>
                      <a:pPr>
                        <a:defRPr lang="ja-JP" sz="1330" b="1" i="0" u="none" strike="noStrike" kern="1200" spc="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値]</a:t>
                    </a:fld>
                    <a:r>
                      <a:rPr lang="en-US" dirty="0">
                        <a:solidFill>
                          <a:schemeClr val="tx1"/>
                        </a:solidFill>
                      </a:rPr>
                      <a:t>%</a:t>
                    </a:r>
                  </a:p>
                </c:rich>
              </c:tx>
              <c:numFmt formatCode="#,##0.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47D5-4FB4-BF6E-6AD4D8DDE98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3D8FEE8D-4C5D-4640-8FE1-BF2F5BAF413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47D5-4FB4-BF6E-6AD4D8DDE98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FBFE355F-2A97-47F5-942B-69EB6F5DF82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47D5-4FB4-BF6E-6AD4D8DDE98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AC60BAAD-BFCB-4A54-8D69-1694C71B87A6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47D5-4FB4-BF6E-6AD4D8DDE984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13EDE0E4-D419-4C5C-94D9-3A9137373381}" type="VALUE">
                      <a:rPr lang="en-US" altLang="ja-JP" smtClean="0"/>
                      <a:pPr/>
                      <a:t>[値]</a:t>
                    </a:fld>
                    <a:r>
                      <a:rPr lang="en-US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47D5-4FB4-BF6E-6AD4D8DDE984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D80FDD9C-4ABD-48A0-A7D7-66E9B3ECB57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47D5-4FB4-BF6E-6AD4D8DDE98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D345246B-D03A-4E97-B1A8-05A9901DEBFB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7D5-4FB4-BF6E-6AD4D8DDE984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7F8BD2E4-DE58-48DA-8A55-FFCE8C8D175A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47D5-4FB4-BF6E-6AD4D8DDE984}"/>
                </c:ext>
              </c:extLst>
            </c:dLbl>
            <c:dLbl>
              <c:idx val="9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1330" b="1" i="0" u="none" strike="noStrike" kern="1200" spc="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E848C676-3696-42F9-814C-AC8DD74F45AC}" type="VALUE">
                      <a:rPr lang="en-US" altLang="ja-JP" smtClean="0"/>
                      <a:pPr>
                        <a:defRPr lang="ja-JP" sz="1330" b="1" i="0" u="none" strike="noStrike" kern="1200" spc="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numFmt formatCode="#,##0.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47D5-4FB4-BF6E-6AD4D8DDE984}"/>
                </c:ext>
              </c:extLst>
            </c:dLbl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330" b="1" i="0" u="none" strike="noStrike" kern="1200" spc="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eparator>
</c:separator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Other</c:v>
                </c:pt>
                <c:pt idx="1">
                  <c:v>Healthcare institutions are too far away for outpatient visits</c:v>
                </c:pt>
                <c:pt idx="2">
                  <c:v>I have no idea where to visit</c:v>
                </c:pt>
                <c:pt idx="3">
                  <c:v>I am worried about COVID-19 infection</c:v>
                </c:pt>
                <c:pt idx="4">
                  <c:v>I have no time for outpatient visits</c:v>
                </c:pt>
                <c:pt idx="5">
                  <c:v>I can manage my pain with over-the-counter drugs</c:v>
                </c:pt>
                <c:pt idx="6">
                  <c:v>My pain was not resolved through outpatient visits in the past</c:v>
                </c:pt>
                <c:pt idx="7">
                  <c:v>I do not believe that my pain can be resolved through outpatient visits</c:v>
                </c:pt>
                <c:pt idx="8">
                  <c:v>Expense</c:v>
                </c:pt>
                <c:pt idx="9">
                  <c:v>My pain is tolerable 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.8</c:v>
                </c:pt>
                <c:pt idx="1">
                  <c:v>0.7</c:v>
                </c:pt>
                <c:pt idx="2">
                  <c:v>2</c:v>
                </c:pt>
                <c:pt idx="3">
                  <c:v>2.2999999999999998</c:v>
                </c:pt>
                <c:pt idx="4">
                  <c:v>4.5999999999999996</c:v>
                </c:pt>
                <c:pt idx="5">
                  <c:v>7.4</c:v>
                </c:pt>
                <c:pt idx="6">
                  <c:v>12.7</c:v>
                </c:pt>
                <c:pt idx="7">
                  <c:v>14.2</c:v>
                </c:pt>
                <c:pt idx="8">
                  <c:v>16.7</c:v>
                </c:pt>
                <c:pt idx="9">
                  <c:v>3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D5-4FB4-BF6E-6AD4D8DDE9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5155800"/>
        <c:axId val="525155472"/>
      </c:barChart>
      <c:valAx>
        <c:axId val="5251554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5155800"/>
        <c:crosses val="autoZero"/>
        <c:crossBetween val="between"/>
      </c:valAx>
      <c:catAx>
        <c:axId val="525155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51554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%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>
              <a:outerShdw blurRad="63500" sx="102000" sy="102000" algn="ctr" rotWithShape="0">
                <a:prstClr val="black">
                  <a:alpha val="20000"/>
                </a:prstClr>
              </a:outerShdw>
            </a:effectLst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47D5-4FB4-BF6E-6AD4D8DDE98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47D5-4FB4-BF6E-6AD4D8DDE98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47D5-4FB4-BF6E-6AD4D8DDE984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47D5-4FB4-BF6E-6AD4D8DDE984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7D5-4FB4-BF6E-6AD4D8DDE984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7D5-4FB4-BF6E-6AD4D8DDE984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47D5-4FB4-BF6E-6AD4D8DDE984}"/>
              </c:ext>
            </c:extLst>
          </c:dPt>
          <c:dPt>
            <c:idx val="7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47D5-4FB4-BF6E-6AD4D8DDE984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47D5-4FB4-BF6E-6AD4D8DDE984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47D5-4FB4-BF6E-6AD4D8DDE984}"/>
              </c:ext>
            </c:extLst>
          </c:dPt>
          <c:dLbls>
            <c:dLbl>
              <c:idx val="0"/>
              <c:tx>
                <c:rich>
                  <a:bodyPr/>
                  <a:lstStyle/>
                  <a:p>
                    <a:fld id="{694FC891-CC06-4370-98A5-D8BC1898B166}" type="VALUE">
                      <a:rPr lang="en-US" altLang="ja-JP" smtClean="0"/>
                      <a:pPr/>
                      <a:t>[値]</a:t>
                    </a:fld>
                    <a:r>
                      <a:rPr lang="en-US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47D5-4FB4-BF6E-6AD4D8DDE984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1330" b="1" i="0" u="none" strike="noStrike" kern="1200" spc="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34C8B33D-5414-4248-9144-AA157632EAAB}" type="VALUE">
                      <a:rPr lang="en-US" altLang="ja-JP" smtClean="0">
                        <a:solidFill>
                          <a:schemeClr val="tx1"/>
                        </a:solidFill>
                      </a:rPr>
                      <a:pPr>
                        <a:defRPr lang="ja-JP" sz="1330" b="1" i="0" u="none" strike="noStrike" kern="1200" spc="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値]</a:t>
                    </a:fld>
                    <a:r>
                      <a:rPr lang="en-US" dirty="0">
                        <a:solidFill>
                          <a:schemeClr val="tx1"/>
                        </a:solidFill>
                      </a:rPr>
                      <a:t>%</a:t>
                    </a:r>
                  </a:p>
                </c:rich>
              </c:tx>
              <c:numFmt formatCode="#,##0.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8-47D5-4FB4-BF6E-6AD4D8DDE984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fld id="{3D8FEE8D-4C5D-4640-8FE1-BF2F5BAF413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7-47D5-4FB4-BF6E-6AD4D8DDE984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fld id="{FBFE355F-2A97-47F5-942B-69EB6F5DF82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6-47D5-4FB4-BF6E-6AD4D8DDE984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fld id="{AC60BAAD-BFCB-4A54-8D69-1694C71B87A6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5-47D5-4FB4-BF6E-6AD4D8DDE984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fld id="{13EDE0E4-D419-4C5C-94D9-3A9137373381}" type="VALUE">
                      <a:rPr lang="en-US" altLang="ja-JP" smtClean="0"/>
                      <a:pPr/>
                      <a:t>[値]</a:t>
                    </a:fld>
                    <a:r>
                      <a:rPr lang="en-US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47D5-4FB4-BF6E-6AD4D8DDE984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fld id="{D80FDD9C-4ABD-48A0-A7D7-66E9B3ECB57C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4-47D5-4FB4-BF6E-6AD4D8DDE984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fld id="{D345246B-D03A-4E97-B1A8-05A9901DEBFB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47D5-4FB4-BF6E-6AD4D8DDE984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fld id="{7F8BD2E4-DE58-48DA-8A55-FFCE8C8D175A}" type="VALUE">
                      <a:rPr lang="en-US" altLang="ja-JP" smtClean="0"/>
                      <a:pPr/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47D5-4FB4-BF6E-6AD4D8DDE984}"/>
                </c:ext>
              </c:extLst>
            </c:dLbl>
            <c:dLbl>
              <c:idx val="9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lang="ja-JP" sz="1330" b="1" i="0" u="none" strike="noStrike" kern="1200" spc="0" baseline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fld id="{E848C676-3696-42F9-814C-AC8DD74F45AC}" type="VALUE">
                      <a:rPr lang="en-US" altLang="ja-JP" smtClean="0"/>
                      <a:pPr>
                        <a:defRPr lang="ja-JP" sz="1330" b="1" i="0" u="none" strike="noStrike" kern="1200" spc="0" baseline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t>[値]</a:t>
                    </a:fld>
                    <a:r>
                      <a:rPr lang="en-US" dirty="0"/>
                      <a:t>%</a:t>
                    </a:r>
                  </a:p>
                </c:rich>
              </c:tx>
              <c:numFmt formatCode="#,##0.0" sourceLinked="0"/>
              <c:spPr>
                <a:noFill/>
                <a:ln>
                  <a:noFill/>
                </a:ln>
                <a:effectLst/>
              </c:sp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A-47D5-4FB4-BF6E-6AD4D8DDE984}"/>
                </c:ext>
              </c:extLst>
            </c:dLbl>
            <c:numFmt formatCode="#,##0.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1330" b="1" i="0" u="none" strike="noStrike" kern="1200" spc="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eparator>
</c:separator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Other</c:v>
                </c:pt>
                <c:pt idx="1">
                  <c:v>Healthcare institutions are too far away for outpatient visits </c:v>
                </c:pt>
                <c:pt idx="2">
                  <c:v>I am worried about COVID-19 infection </c:v>
                </c:pt>
                <c:pt idx="3">
                  <c:v>I have no time for outpatient visits </c:v>
                </c:pt>
                <c:pt idx="4">
                  <c:v>I have no idea where to visit </c:v>
                </c:pt>
                <c:pt idx="5">
                  <c:v>My pain was not resolved through outpatient visits in the past </c:v>
                </c:pt>
                <c:pt idx="6">
                  <c:v>I do not believe that my pain can be resolved through outpatient visits </c:v>
                </c:pt>
                <c:pt idx="7">
                  <c:v>Expense </c:v>
                </c:pt>
                <c:pt idx="8">
                  <c:v>My pain is tolerable </c:v>
                </c:pt>
                <c:pt idx="9">
                  <c:v>I can manage my pain with over-the-counter drugs 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7.5</c:v>
                </c:pt>
                <c:pt idx="1">
                  <c:v>1</c:v>
                </c:pt>
                <c:pt idx="2">
                  <c:v>1.9</c:v>
                </c:pt>
                <c:pt idx="3">
                  <c:v>3.2</c:v>
                </c:pt>
                <c:pt idx="4">
                  <c:v>3.7</c:v>
                </c:pt>
                <c:pt idx="5">
                  <c:v>5.8</c:v>
                </c:pt>
                <c:pt idx="6">
                  <c:v>10.1</c:v>
                </c:pt>
                <c:pt idx="7">
                  <c:v>13.2</c:v>
                </c:pt>
                <c:pt idx="8">
                  <c:v>13.4</c:v>
                </c:pt>
                <c:pt idx="9">
                  <c:v>40.2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D5-4FB4-BF6E-6AD4D8DDE98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525155800"/>
        <c:axId val="525155472"/>
      </c:barChart>
      <c:valAx>
        <c:axId val="5251554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5155800"/>
        <c:crosses val="autoZero"/>
        <c:crossBetween val="between"/>
      </c:valAx>
      <c:catAx>
        <c:axId val="5251558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51554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ABBCDB-1CBA-4F61-952C-9E4E6375FE9B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3013"/>
            <a:ext cx="48450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8BD605-927F-434F-8889-E6CB15D38E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96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433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84906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3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9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0018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1300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0" y="1709742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0" y="4589467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171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40569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9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2049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4825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164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9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4268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9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9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1661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9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2DB75-B003-4FFF-9197-184C1A59BF87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698D3-9462-495D-8F52-08214C630B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3038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27">
            <a:extLst>
              <a:ext uri="{FF2B5EF4-FFF2-40B4-BE49-F238E27FC236}">
                <a16:creationId xmlns:a16="http://schemas.microsoft.com/office/drawing/2014/main" id="{6C28E5F3-550D-F7A5-17C8-ABB6BAC43D7C}"/>
              </a:ext>
            </a:extLst>
          </p:cNvPr>
          <p:cNvSpPr txBox="1"/>
          <p:nvPr/>
        </p:nvSpPr>
        <p:spPr>
          <a:xfrm>
            <a:off x="51876" y="9236"/>
            <a:ext cx="980702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A.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imary </a:t>
            </a:r>
            <a:r>
              <a:rPr kumimoji="1" lang="en-NZ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ason for not seeking treatment in untreated patients with chronic pain (primary endpoint)</a:t>
            </a:r>
            <a:r>
              <a:rPr kumimoji="1" lang="en-NZ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en-NZ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6F585C8-F8AE-2296-6BC8-BBACFA3778C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17605532"/>
              </p:ext>
            </p:extLst>
          </p:nvPr>
        </p:nvGraphicFramePr>
        <p:xfrm>
          <a:off x="314037" y="697345"/>
          <a:ext cx="9372599" cy="59759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C0774F7-4A14-C116-5E0C-79C784628E89}"/>
              </a:ext>
            </a:extLst>
          </p:cNvPr>
          <p:cNvSpPr txBox="1"/>
          <p:nvPr/>
        </p:nvSpPr>
        <p:spPr>
          <a:xfrm>
            <a:off x="51876" y="6459789"/>
            <a:ext cx="1973569" cy="3783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14300" marR="127000">
              <a:lnSpc>
                <a:spcPct val="200000"/>
              </a:lnSpc>
              <a:spcAft>
                <a:spcPts val="0"/>
              </a:spcAft>
            </a:pPr>
            <a:r>
              <a:rPr lang="en-NZ" sz="1050" baseline="300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NZ" sz="105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Only</a:t>
            </a:r>
            <a:r>
              <a:rPr lang="en-NZ" sz="105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one reason allowed</a:t>
            </a:r>
            <a:endParaRPr lang="en-GB" sz="1050" dirty="0">
              <a:effectLst/>
              <a:latin typeface="Arial" panose="020B060402020202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25076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27">
            <a:extLst>
              <a:ext uri="{FF2B5EF4-FFF2-40B4-BE49-F238E27FC236}">
                <a16:creationId xmlns:a16="http://schemas.microsoft.com/office/drawing/2014/main" id="{6C28E5F3-550D-F7A5-17C8-ABB6BAC43D7C}"/>
              </a:ext>
            </a:extLst>
          </p:cNvPr>
          <p:cNvSpPr txBox="1"/>
          <p:nvPr/>
        </p:nvSpPr>
        <p:spPr>
          <a:xfrm>
            <a:off x="51876" y="9236"/>
            <a:ext cx="9807024" cy="52322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B.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Primary </a:t>
            </a:r>
            <a:r>
              <a:rPr kumimoji="1" lang="en-NZ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reason for not seeking treatment in untreated patients with migraine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kumimoji="1" lang="en-NZ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(primary endpoint)</a:t>
            </a:r>
            <a:r>
              <a:rPr kumimoji="1" lang="en-NZ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en-NZ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F6F585C8-F8AE-2296-6BC8-BBACFA3778C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87618373"/>
              </p:ext>
            </p:extLst>
          </p:nvPr>
        </p:nvGraphicFramePr>
        <p:xfrm>
          <a:off x="314037" y="697345"/>
          <a:ext cx="9372599" cy="59759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E74FF3BA-D927-6357-76DC-E22AD43409D9}"/>
              </a:ext>
            </a:extLst>
          </p:cNvPr>
          <p:cNvSpPr txBox="1"/>
          <p:nvPr/>
        </p:nvSpPr>
        <p:spPr>
          <a:xfrm>
            <a:off x="51876" y="6459789"/>
            <a:ext cx="1973569" cy="3783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14300" marR="127000">
              <a:lnSpc>
                <a:spcPct val="200000"/>
              </a:lnSpc>
              <a:spcAft>
                <a:spcPts val="0"/>
              </a:spcAft>
            </a:pPr>
            <a:r>
              <a:rPr lang="en-NZ" sz="1050" baseline="3000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a</a:t>
            </a:r>
            <a:r>
              <a:rPr lang="en-NZ" sz="1050" dirty="0" err="1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Only</a:t>
            </a:r>
            <a:r>
              <a:rPr lang="en-NZ" sz="105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Times New Roman" panose="02020603050405020304" pitchFamily="18" charset="0"/>
              </a:rPr>
              <a:t> one reason allowed</a:t>
            </a:r>
            <a:endParaRPr lang="en-GB" sz="1050" dirty="0">
              <a:effectLst/>
              <a:latin typeface="Arial" panose="020B0604020202020204" pitchFamily="34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0145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BECD34EC31341A44B727E618D4AB7E0F" ma:contentTypeVersion="2" ma:contentTypeDescription="新しいドキュメントを作成します。" ma:contentTypeScope="" ma:versionID="d01f73dbe370998e9f1e4ce450e6181c">
  <xsd:schema xmlns:xsd="http://www.w3.org/2001/XMLSchema" xmlns:xs="http://www.w3.org/2001/XMLSchema" xmlns:p="http://schemas.microsoft.com/office/2006/metadata/properties" xmlns:ns2="2e74164c-17bd-43b9-974f-36174d371fa9" targetNamespace="http://schemas.microsoft.com/office/2006/metadata/properties" ma:root="true" ma:fieldsID="5790e29d76961c83847a1f87b452f169" ns2:_="">
    <xsd:import namespace="2e74164c-17bd-43b9-974f-36174d371fa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e74164c-17bd-43b9-974f-36174d371fa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2E51E9D0-D77B-4821-925B-6920C2EE4FB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e74164c-17bd-43b9-974f-36174d371fa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6E26DA7-9959-40F0-8911-16CFCE88829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FD05348-28CF-46E3-8531-81F45ACD248B}">
  <ds:schemaRefs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purl.org/dc/terms/"/>
    <ds:schemaRef ds:uri="2e74164c-17bd-43b9-974f-36174d371fa9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58</TotalTime>
  <Words>90</Words>
  <Application>Microsoft Office PowerPoint</Application>
  <PresentationFormat>A4 210 x 297 mm</PresentationFormat>
  <Paragraphs>24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>MEBI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上 篤史(Mebix)</dc:creator>
  <cp:lastModifiedBy>Yusuke Karasawa</cp:lastModifiedBy>
  <cp:revision>110</cp:revision>
  <cp:lastPrinted>2019-05-16T05:27:54Z</cp:lastPrinted>
  <dcterms:created xsi:type="dcterms:W3CDTF">2019-05-09T09:45:02Z</dcterms:created>
  <dcterms:modified xsi:type="dcterms:W3CDTF">2023-09-20T07:28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ECD34EC31341A44B727E618D4AB7E0F</vt:lpwstr>
  </property>
  <property fmtid="{D5CDD505-2E9C-101B-9397-08002B2CF9AE}" pid="3" name="MediaServiceImageTags">
    <vt:lpwstr/>
  </property>
</Properties>
</file>